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25"/>
    <p:restoredTop sz="94703"/>
  </p:normalViewPr>
  <p:slideViewPr>
    <p:cSldViewPr snapToGrid="0">
      <p:cViewPr varScale="1">
        <p:scale>
          <a:sx n="81" d="100"/>
          <a:sy n="81" d="100"/>
        </p:scale>
        <p:origin x="89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0542385-2C54-B399-F775-FB128085AA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5CC4A02-C716-D0E2-38A7-ED14BD9FB9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152B2B0-E1F1-7C5C-E5A8-528C1D823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A31B024-15ED-B6F1-C286-39F085E97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5696630-D854-D037-E7CF-4E21D0CB2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539747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C10EA7-4B38-79E5-3FF9-2FEF73B0A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42ADA76-C3C8-77F2-023B-CF5034823A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AE7832F-D9F0-D6FB-9F4F-549385943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F67CADF-3697-7B74-B05A-8F6B59E01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FA55A64-8BB0-0A0D-0898-4E0654B8F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28154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4EF8F19-7B06-CA39-CEEC-658462A765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4558F18-9196-B191-EE28-D8367A86ED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3A7385C-6B46-A57A-4BF7-88085B4ED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3B2246-0240-A1C6-2C1F-1615893E4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7290A2E-E118-D951-15EA-411431734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1087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404F059-CA0D-A4DB-3323-3555C8772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8858A08-0414-F191-7F64-8EA13C3F70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5800D54-886D-35B3-47D3-EC78A85AC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2F96072-3E96-1BFB-579E-03A84627D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4FF552E-C2E3-9E1A-740E-22BB1E30C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95545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F93380-F740-3B8B-9641-21348C0ED8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6DFCEC9-9968-13FC-3B69-59EA2FAB8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E509121-1B21-5592-6127-F8888556B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D96FBF8-CAE5-9288-DF67-E4CBDE99B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033FC93-5EB3-A0AF-2725-F87A836A0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32381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26F09B8-A9AE-4754-B8F6-B912E8C904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580F85-95DB-CFA8-A0BF-2691383E1B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B819DBF-960E-4E58-F45E-3B900FC64B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9EACD5B-274C-4E49-C11B-A33180234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6BF7A34-A392-84BD-18E9-531986AF9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0256E6A-184A-0952-A00F-2152FF85B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77193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14245C-425D-76AD-185D-224CC3D78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2E76FCD-2230-2B9D-B9D9-C8EA8A372C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82525DC-B5A6-C35E-2DA7-C7CE1AE348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63C703E-674F-F29E-F6BA-5FFFC808A8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2EA8EC97-1B81-233A-E31C-48196C3ACF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7F01519-B69A-041C-4390-8B18555CA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B69135A-F889-B9ED-4679-8C33E9A74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699FEA2-BFFC-39C4-A3E5-B654972E3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094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C6F4310-8C97-ACC4-656A-FFCFD7F93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870AE97-7C73-5F06-8BB1-2B70EDD27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3013C26-36AB-F525-44C6-932355CE3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A98FFED-1AFF-FE84-542C-5858F5C36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45999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0E1FEB-FEC8-2711-DFBB-B1F8E2854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9F6E189-7942-6F97-1EC4-0CC6FD5DE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C6A7159-CE24-DC56-ED19-B4E996355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416423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A80ACE6-B021-0C95-2573-76BE1CA2F5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E94CB5A-E110-CFA1-EB2E-E0DEC0198A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4C515BF-36F0-B646-B8DA-43DF2C1599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026D786-E361-9D58-AA0E-D2DCE126C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C551D5C-1631-E09E-6382-87A32E432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67F5F02-EFEF-9628-AF7C-7C592F0AF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504944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B9AC000-6C96-9205-A199-B81470808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2DA3C77F-81F5-86C6-9403-3820E83DAD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F31EFA2-9302-A68D-F324-409DD22C6C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14E1895-EDA8-133C-7578-0176EE508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8C11717-F31B-526E-058F-B2B2FFEF5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71762FB-FFF1-C1A1-8499-163F9DAC8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249831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9F73FD0-0DDD-C63B-B87B-F623B0BDF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58BD5B9-F9A2-E5F4-0BFF-031A78615C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6591020-79EB-C1ED-06A1-6367F2E8F9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6C68A-CF39-4845-A49C-8636418C9841}" type="datetimeFigureOut">
              <a:rPr kumimoji="1" lang="ko-KR" altLang="en-US" smtClean="0"/>
              <a:t>2024-02-26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14A681-CD03-4B47-3ABC-1BCACD1022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B6C0414-5252-9AF3-4E79-076E425390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BF945-0862-2E4E-ADE0-20EE21F9898D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725467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AC330BF7-6A12-58D8-BB68-FE40BEA8748A}"/>
              </a:ext>
            </a:extLst>
          </p:cNvPr>
          <p:cNvSpPr txBox="1"/>
          <p:nvPr/>
        </p:nvSpPr>
        <p:spPr>
          <a:xfrm>
            <a:off x="56065" y="44851"/>
            <a:ext cx="3852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unnel plots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FB9E4290-9E73-23CB-4749-DEC849AD13CD}"/>
              </a:ext>
            </a:extLst>
          </p:cNvPr>
          <p:cNvGrpSpPr/>
          <p:nvPr/>
        </p:nvGrpSpPr>
        <p:grpSpPr>
          <a:xfrm>
            <a:off x="2165856" y="993226"/>
            <a:ext cx="8626421" cy="5782764"/>
            <a:chOff x="2165856" y="993226"/>
            <a:chExt cx="8626421" cy="5782764"/>
          </a:xfrm>
        </p:grpSpPr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7A7D99C3-A951-54BF-D6D9-824933F26B63}"/>
                </a:ext>
              </a:extLst>
            </p:cNvPr>
            <p:cNvGrpSpPr/>
            <p:nvPr/>
          </p:nvGrpSpPr>
          <p:grpSpPr>
            <a:xfrm>
              <a:off x="2165856" y="1027327"/>
              <a:ext cx="8626421" cy="5748663"/>
              <a:chOff x="2165856" y="1027327"/>
              <a:chExt cx="8626421" cy="5748663"/>
            </a:xfrm>
          </p:grpSpPr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A111171F-C19A-A35E-8078-89C50A2426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165856" y="1177892"/>
                <a:ext cx="3554799" cy="2420104"/>
              </a:xfrm>
              <a:prstGeom prst="rect">
                <a:avLst/>
              </a:prstGeom>
            </p:spPr>
          </p:pic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B6799297-A642-54CB-99F3-365A537FF3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237478" y="1211993"/>
                <a:ext cx="3554799" cy="2427942"/>
              </a:xfrm>
              <a:prstGeom prst="rect">
                <a:avLst/>
              </a:prstGeom>
            </p:spPr>
          </p:pic>
          <p:pic>
            <p:nvPicPr>
              <p:cNvPr id="14" name="그림 13">
                <a:extLst>
                  <a:ext uri="{FF2B5EF4-FFF2-40B4-BE49-F238E27FC236}">
                    <a16:creationId xmlns:a16="http://schemas.microsoft.com/office/drawing/2014/main" id="{CC5A164D-2A21-9C7E-CB82-5372B399A7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165858" y="4341605"/>
                <a:ext cx="3554798" cy="2432646"/>
              </a:xfrm>
              <a:prstGeom prst="rect">
                <a:avLst/>
              </a:prstGeom>
            </p:spPr>
          </p:pic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60F5F40B-0373-CE4A-BAFB-EC4A60064FA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224653" y="4339865"/>
                <a:ext cx="3567624" cy="2436125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20448419-386C-63DA-2AA8-5D36ECF3551A}"/>
                  </a:ext>
                </a:extLst>
              </p:cNvPr>
              <p:cNvSpPr txBox="1"/>
              <p:nvPr/>
            </p:nvSpPr>
            <p:spPr>
              <a:xfrm>
                <a:off x="7243147" y="1027327"/>
                <a:ext cx="18473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kumimoji="1" lang="ko-KR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6EC4C95-0407-240D-7604-89ACE39C6A22}"/>
                </a:ext>
              </a:extLst>
            </p:cNvPr>
            <p:cNvSpPr txBox="1"/>
            <p:nvPr/>
          </p:nvSpPr>
          <p:spPr>
            <a:xfrm>
              <a:off x="2197357" y="993226"/>
              <a:ext cx="38253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27BC7F6-964F-5BE9-04B7-1C8903609D4D}"/>
                </a:ext>
              </a:extLst>
            </p:cNvPr>
            <p:cNvSpPr txBox="1"/>
            <p:nvPr/>
          </p:nvSpPr>
          <p:spPr>
            <a:xfrm>
              <a:off x="3377231" y="993226"/>
              <a:ext cx="149642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studies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FF2679C-3EEE-E23B-34DE-4FA0BC364865}"/>
                </a:ext>
              </a:extLst>
            </p:cNvPr>
            <p:cNvSpPr txBox="1"/>
            <p:nvPr/>
          </p:nvSpPr>
          <p:spPr>
            <a:xfrm>
              <a:off x="2227731" y="4185220"/>
              <a:ext cx="43127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F345222-57BB-B4F7-9BC8-29CE02A12F3A}"/>
                </a:ext>
              </a:extLst>
            </p:cNvPr>
            <p:cNvSpPr txBox="1"/>
            <p:nvPr/>
          </p:nvSpPr>
          <p:spPr>
            <a:xfrm>
              <a:off x="2815214" y="4185220"/>
              <a:ext cx="257691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ies for mental fatigue 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8E2D1A9-7BA9-1071-B115-A3ED5D7A8842}"/>
                </a:ext>
              </a:extLst>
            </p:cNvPr>
            <p:cNvSpPr txBox="1"/>
            <p:nvPr/>
          </p:nvSpPr>
          <p:spPr>
            <a:xfrm>
              <a:off x="7307508" y="1044365"/>
              <a:ext cx="39511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1EE6195-2134-C7DE-E7F5-DDF31AFD6BFD}"/>
                </a:ext>
              </a:extLst>
            </p:cNvPr>
            <p:cNvSpPr txBox="1"/>
            <p:nvPr/>
          </p:nvSpPr>
          <p:spPr>
            <a:xfrm>
              <a:off x="7792188" y="1044365"/>
              <a:ext cx="291052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ies for physical fatigue 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64FC7A8-28D4-F62F-BB5D-235540A7F573}"/>
                </a:ext>
              </a:extLst>
            </p:cNvPr>
            <p:cNvSpPr txBox="1"/>
            <p:nvPr/>
          </p:nvSpPr>
          <p:spPr>
            <a:xfrm>
              <a:off x="7281724" y="4185220"/>
              <a:ext cx="33001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EDFE33F-50C7-BB74-CA68-68FCEE24D721}"/>
                </a:ext>
              </a:extLst>
            </p:cNvPr>
            <p:cNvSpPr txBox="1"/>
            <p:nvPr/>
          </p:nvSpPr>
          <p:spPr>
            <a:xfrm>
              <a:off x="7727235" y="4185220"/>
              <a:ext cx="284453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ko-KR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ies for cognitive fatigue </a:t>
              </a:r>
              <a:endParaRPr kumimoji="1"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97387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23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병진</dc:creator>
  <cp:lastModifiedBy>재웅 박</cp:lastModifiedBy>
  <cp:revision>5</cp:revision>
  <dcterms:created xsi:type="dcterms:W3CDTF">2024-02-23T11:50:05Z</dcterms:created>
  <dcterms:modified xsi:type="dcterms:W3CDTF">2024-02-26T03:29:24Z</dcterms:modified>
</cp:coreProperties>
</file>